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AF49B-A9E6-413B-A068-A33113E1994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93CB8-9BC8-4887-9E86-AA09E68179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9C22C-9F19-4641-99F1-10FD53D21FF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704C26-9279-4940-8ECF-F545143928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126F1F-70C6-478C-8179-D2E716F8EC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02587-BDEE-491C-B7F7-8981EB9E09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E79935-E618-4393-9568-9CF1C84125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0FF7C-3A69-4914-BE33-85EF67B58C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2FC99-60ED-4E38-873F-AA6307AFF2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6D11E0-DDFB-427B-82BC-A167A0136E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65514-CD21-4ED3-80AF-D0F70322DC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C23A6-ABE9-4AA3-86D1-CA4ED559D7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A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FF2CB2-1E28-4798-B3F8-30E4F6B26991}" type="slidenum">
              <a:rPr b="0" lang="de-A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531720" y="669960"/>
            <a:ext cx="546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Table S3. Summary of small RNAs Reads in Epiallele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2000"/>
          <p:cNvSpPr/>
          <p:nvPr/>
        </p:nvSpPr>
        <p:spPr>
          <a:xfrm>
            <a:off x="2689920" y="169920"/>
            <a:ext cx="127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Foerster et al., Table S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598320" y="1077840"/>
          <a:ext cx="5732640" cy="7997760"/>
        </p:xfrm>
        <a:graphic>
          <a:graphicData uri="http://schemas.openxmlformats.org/drawingml/2006/table">
            <a:tbl>
              <a:tblPr/>
              <a:tblGrid>
                <a:gridCol w="738360"/>
                <a:gridCol w="633240"/>
                <a:gridCol w="2379960"/>
                <a:gridCol w="831600"/>
                <a:gridCol w="598680"/>
                <a:gridCol w="550800"/>
              </a:tblGrid>
              <a:tr h="33804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pialle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engt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qu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tched Positions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tran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8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# of rea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AGAATCAGGGGATAACGC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21, 58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AGCTGTTTCCTGTGTGAAA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31, 62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5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TGTTAGGTCCTCTATTTGAA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84, 62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TCCTATGTCTCCTATGTC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0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64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CTTCGATGTAGGAGGGCGT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5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AACGACCGAGCGCAGCGAG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93, 59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AACCGTATTACCGCCTTT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45, 59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604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CATAACGATCTTTGTAGAAA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5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CGATCTTTGTAGAAACCATC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5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5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TCTTTGACTCCATGGGAATT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1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AGACTCTGTATGAACTGTTC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25, 63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CTGGGCAATGGAATCCGAGG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089, 64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CGACGCTCAAGTCAGAGGTG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93, 57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CTCAGTTCGGTGTAGGTCG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19, 55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7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CTTTGACTCCATGGGAATTG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1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864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TGGGAATTGTTTTTTGCTGC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1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5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ACAGGACTATAAAGATACCA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63, 57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GGAGACGCTGTCGAACTTTTC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4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CGTGATTCCTATGTCTCCTAT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0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GAGACGCTGTCGAACTTTTCG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4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GAGCTTGAAGGACTCCAGAG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0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7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TGGAGTAGACAAGCGTGTCGT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92, 63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AGCGGGCAGTGAGCGCAACG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16, 60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ACGACCTACACCGAACTGAGA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20, 55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ACCGAACTGAGATACCTAC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28, 56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GAATTCCCATGGAGTCAAAG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63, 62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64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CTGAGATACCTACAGCGTGAGC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235, 56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TCAGTGAGCGAGGAAGCGGA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12, 59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7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GTGTGAGTATAAACCTGCG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5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TGTGAAGATAGTGGAAAAGGA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25, 65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5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GTGAGCGAGGAAGCGGAAG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615, 59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TTGCCCAGCTATCTGTCACT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01, 64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AGATAGTGGAAAAGGAAGGT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30, 65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TCTGTGGATAACCGTATTAC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36, 59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TGAAGATAGTGGAAAAGGAAG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28, 65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AGGAGACATAGGAATCACGC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0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AAGACATAGGAGACATAGGAA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0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CTGATTCTGTGGATAACCGTA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90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CTGATTCTGTGGATAACCGTAT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9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TGTGGAATTGTGAGCGGATA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807, 61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6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Text Box 3698"/>
          <p:cNvSpPr/>
          <p:nvPr/>
        </p:nvSpPr>
        <p:spPr>
          <a:xfrm>
            <a:off x="569880" y="9153360"/>
            <a:ext cx="546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 in the transgenic inse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16T09:07:43Z</dcterms:created>
  <dc:creator>Andrea</dc:creator>
  <dc:description/>
  <dc:language>en-US</dc:language>
  <cp:lastModifiedBy>Mittelsten Scheid, Ortrun</cp:lastModifiedBy>
  <dcterms:modified xsi:type="dcterms:W3CDTF">2011-08-31T09:30:41Z</dcterms:modified>
  <cp:revision>111</cp:revision>
  <dc:subject/>
  <dc:title>Slide 1</dc:title>
</cp:coreProperties>
</file>